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452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0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723900" y="283458"/>
            <a:ext cx="7696200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upplementary Figure 1: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SM Indexed phylogenetic tree of 112 rice lines constructed using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NTSYSpc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software. (Details of S1 to S112 is given in supplementary Table 4)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5" name="Picture 1" descr="Description: H:\NICRA fina Scientific Reports\120523\Figure 4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914400"/>
            <a:ext cx="8382000" cy="56669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0" y="4333875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2778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Akib Ali\Desktop\New folder\3rd NICRA sci\Figure 5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1549" y="1600200"/>
            <a:ext cx="7199313" cy="50847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685800" y="304800"/>
            <a:ext cx="82296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upplementary Figure </a:t>
            </a:r>
            <a:r>
              <a:rPr lang="en-US" sz="1200" b="1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2</a:t>
            </a:r>
            <a:r>
              <a:rPr lang="en-IN" sz="1200" b="1" dirty="0" smtClean="0"/>
              <a:t>:</a:t>
            </a:r>
            <a:r>
              <a:rPr lang="en-IN" sz="1200" dirty="0" smtClean="0"/>
              <a:t> </a:t>
            </a:r>
            <a:r>
              <a:rPr lang="en-IN" sz="1200" dirty="0"/>
              <a:t>Heat map representations of PEG-induced fold expression changes (with mock-treated control) of </a:t>
            </a:r>
            <a:r>
              <a:rPr lang="en-IN" sz="1200" dirty="0" err="1"/>
              <a:t>drough</a:t>
            </a:r>
            <a:r>
              <a:rPr lang="en-IN" sz="1200" dirty="0"/>
              <a:t>-responsive genes viz., </a:t>
            </a:r>
            <a:r>
              <a:rPr lang="en-IN" sz="1200" i="1" dirty="0"/>
              <a:t>DREB1, p5cs, </a:t>
            </a:r>
            <a:r>
              <a:rPr lang="en-IN" sz="1200" i="1" dirty="0" err="1"/>
              <a:t>rbcs</a:t>
            </a:r>
            <a:r>
              <a:rPr lang="en-IN" sz="1200" i="1" dirty="0"/>
              <a:t>, AAO1, SOD, WRKY11, WRKY114, SDR1, NAC9, ZFP252, ZFP182 </a:t>
            </a:r>
            <a:r>
              <a:rPr lang="en-IN" sz="1200" dirty="0"/>
              <a:t>and </a:t>
            </a:r>
            <a:r>
              <a:rPr lang="en-IN" sz="1200" i="1" dirty="0"/>
              <a:t>DRAP1</a:t>
            </a:r>
            <a:r>
              <a:rPr lang="en-IN" sz="1200" dirty="0"/>
              <a:t> in the shoot (a) and root (b) tissues of rice genotype namely, </a:t>
            </a:r>
            <a:r>
              <a:rPr lang="en-IN" sz="1200" dirty="0" err="1"/>
              <a:t>Sahbhagi</a:t>
            </a:r>
            <a:r>
              <a:rPr lang="en-IN" sz="1200" dirty="0"/>
              <a:t> </a:t>
            </a:r>
            <a:r>
              <a:rPr lang="en-IN" sz="1200" dirty="0" err="1"/>
              <a:t>dhan</a:t>
            </a:r>
            <a:r>
              <a:rPr lang="en-IN" sz="1200" dirty="0"/>
              <a:t>, RCPL-1-82, IR64 and RCPL-1-185</a:t>
            </a:r>
          </a:p>
          <a:p>
            <a:endParaRPr lang="en-IN" sz="1200" dirty="0"/>
          </a:p>
        </p:txBody>
      </p:sp>
    </p:spTree>
    <p:extLst>
      <p:ext uri="{BB962C8B-B14F-4D97-AF65-F5344CB8AC3E}">
        <p14:creationId xmlns:p14="http://schemas.microsoft.com/office/powerpoint/2010/main" val="14276151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Akib Ali\Desktop\3rd NICRA sci\New folder\Figure 6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0" y="1066800"/>
            <a:ext cx="6037263" cy="52837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228600" y="75040"/>
            <a:ext cx="8763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ementary figure 3: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Representativ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picture showing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Sahbhagi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dhan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RCPL-1-82, IR64 and RCPL-1-185 seedling maintained at control (well watered) and 50% water deficit conditi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; 6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pictur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showing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Sahbhagi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dhan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RCPL-1-82, IR64 and RCPL-1-185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at flowering stages maintained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t control (well watered) and 50% water deficit conditi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; c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picture representing fertile pollen (round shaped and dark stained) and  sterile pollen (broken pollen and light stained) under pollen fertility test using I</a:t>
            </a:r>
            <a:r>
              <a:rPr lang="en-US" sz="1200" baseline="-25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-KI</a:t>
            </a:r>
            <a:endParaRPr lang="en-I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27091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</TotalTime>
  <Words>192</Words>
  <Application>Microsoft Office PowerPoint</Application>
  <PresentationFormat>On-screen Show (4:3)</PresentationFormat>
  <Paragraphs>3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kib</dc:creator>
  <cp:lastModifiedBy>Akib Ali</cp:lastModifiedBy>
  <cp:revision>7</cp:revision>
  <dcterms:created xsi:type="dcterms:W3CDTF">2006-08-16T00:00:00Z</dcterms:created>
  <dcterms:modified xsi:type="dcterms:W3CDTF">2023-10-13T11:23:48Z</dcterms:modified>
</cp:coreProperties>
</file>